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4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88" autoAdjust="0"/>
    <p:restoredTop sz="94660"/>
  </p:normalViewPr>
  <p:slideViewPr>
    <p:cSldViewPr snapToGrid="0">
      <p:cViewPr varScale="1">
        <p:scale>
          <a:sx n="66" d="100"/>
          <a:sy n="66" d="100"/>
        </p:scale>
        <p:origin x="9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8BBF08A1-661E-2C99-C49D-36CEE6288376}"/>
              </a:ext>
            </a:extLst>
          </p:cNvPr>
          <p:cNvGraphicFramePr>
            <a:graphicFrameLocks noGrp="1"/>
          </p:cNvGraphicFramePr>
          <p:nvPr/>
        </p:nvGraphicFramePr>
        <p:xfrm>
          <a:off x="822084" y="605468"/>
          <a:ext cx="2241008" cy="1144905"/>
        </p:xfrm>
        <a:graphic>
          <a:graphicData uri="http://schemas.openxmlformats.org/drawingml/2006/table">
            <a:tbl>
              <a:tblPr/>
              <a:tblGrid>
                <a:gridCol w="1232295">
                  <a:extLst>
                    <a:ext uri="{9D8B030D-6E8A-4147-A177-3AD203B41FA5}">
                      <a16:colId xmlns:a16="http://schemas.microsoft.com/office/drawing/2014/main" val="1153142289"/>
                    </a:ext>
                  </a:extLst>
                </a:gridCol>
                <a:gridCol w="1008713">
                  <a:extLst>
                    <a:ext uri="{9D8B030D-6E8A-4147-A177-3AD203B41FA5}">
                      <a16:colId xmlns:a16="http://schemas.microsoft.com/office/drawing/2014/main" val="2272933917"/>
                    </a:ext>
                  </a:extLst>
                </a:gridCol>
              </a:tblGrid>
              <a:tr h="362522"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number of osteocytes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1842478"/>
                  </a:ext>
                </a:extLst>
              </a:tr>
              <a:tr h="185219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Young_Femal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490339"/>
                  </a:ext>
                </a:extLst>
              </a:tr>
              <a:tr h="185219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ld_Femal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9821700"/>
                  </a:ext>
                </a:extLst>
              </a:tr>
              <a:tr h="185219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Young_Mal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5535247"/>
                  </a:ext>
                </a:extLst>
              </a:tr>
              <a:tr h="185219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ld_Mal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1694304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EE21DEC-CE93-17CB-88B0-2458282733B4}"/>
              </a:ext>
            </a:extLst>
          </p:cNvPr>
          <p:cNvSpPr txBox="1"/>
          <p:nvPr/>
        </p:nvSpPr>
        <p:spPr>
          <a:xfrm>
            <a:off x="456175" y="463275"/>
            <a:ext cx="328330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2000" b="1" dirty="0">
                <a:latin typeface="Arial Narrow" panose="020B0606020202030204" pitchFamily="34" charset="0"/>
              </a:rPr>
              <a:t>A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18C9A67-DC27-934D-DDBF-7A331C7C1668}"/>
              </a:ext>
            </a:extLst>
          </p:cNvPr>
          <p:cNvGrpSpPr/>
          <p:nvPr/>
        </p:nvGrpSpPr>
        <p:grpSpPr>
          <a:xfrm>
            <a:off x="3356269" y="463274"/>
            <a:ext cx="1661478" cy="3571469"/>
            <a:chOff x="4284120" y="463274"/>
            <a:chExt cx="1661478" cy="357146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B637D14-5DA9-B1DA-2C49-9DF9FDE8A91D}"/>
                </a:ext>
              </a:extLst>
            </p:cNvPr>
            <p:cNvSpPr txBox="1"/>
            <p:nvPr/>
          </p:nvSpPr>
          <p:spPr>
            <a:xfrm>
              <a:off x="4284120" y="463274"/>
              <a:ext cx="328330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 Narrow" panose="020B0606020202030204" pitchFamily="34" charset="0"/>
                </a:rPr>
                <a:t>B</a:t>
              </a:r>
            </a:p>
          </p:txBody>
        </p:sp>
        <p:pic>
          <p:nvPicPr>
            <p:cNvPr id="6" name="Picture 5" descr="A graph with a red and green bar graph&#10;&#10;AI-generated content may be incorrect.">
              <a:extLst>
                <a:ext uri="{FF2B5EF4-FFF2-40B4-BE49-F238E27FC236}">
                  <a16:creationId xmlns:a16="http://schemas.microsoft.com/office/drawing/2014/main" id="{C2838F55-9907-803B-D2AE-27E7170512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08957" y="863385"/>
              <a:ext cx="1536641" cy="3171358"/>
            </a:xfrm>
            <a:prstGeom prst="rect">
              <a:avLst/>
            </a:prstGeom>
          </p:spPr>
        </p:pic>
      </p:grpSp>
      <p:pic>
        <p:nvPicPr>
          <p:cNvPr id="21" name="Picture 20" descr="A green square with black border&#10;&#10;AI-generated content may be incorrect.">
            <a:extLst>
              <a:ext uri="{FF2B5EF4-FFF2-40B4-BE49-F238E27FC236}">
                <a16:creationId xmlns:a16="http://schemas.microsoft.com/office/drawing/2014/main" id="{74F7E938-3F8B-7C68-E85D-C69534817B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2270" y="567048"/>
            <a:ext cx="877808" cy="192563"/>
          </a:xfrm>
          <a:prstGeom prst="rect">
            <a:avLst/>
          </a:prstGeom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id="{C83B5F99-55BA-901B-F384-DC8E555C69AF}"/>
              </a:ext>
            </a:extLst>
          </p:cNvPr>
          <p:cNvGrpSpPr/>
          <p:nvPr/>
        </p:nvGrpSpPr>
        <p:grpSpPr>
          <a:xfrm>
            <a:off x="456175" y="1809801"/>
            <a:ext cx="2858399" cy="2224943"/>
            <a:chOff x="456175" y="1809801"/>
            <a:chExt cx="2858399" cy="222494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985BE54-335D-4A3A-3C22-8ECA9025817D}"/>
                </a:ext>
              </a:extLst>
            </p:cNvPr>
            <p:cNvSpPr txBox="1"/>
            <p:nvPr/>
          </p:nvSpPr>
          <p:spPr>
            <a:xfrm>
              <a:off x="456175" y="1809801"/>
              <a:ext cx="328330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 Narrow" panose="020B0606020202030204" pitchFamily="34" charset="0"/>
                </a:rPr>
                <a:t>C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593C9BF-8AA7-5BC4-953B-E54CBF871912}"/>
                </a:ext>
              </a:extLst>
            </p:cNvPr>
            <p:cNvGrpSpPr/>
            <p:nvPr/>
          </p:nvGrpSpPr>
          <p:grpSpPr>
            <a:xfrm>
              <a:off x="620340" y="2014951"/>
              <a:ext cx="2694234" cy="2019793"/>
              <a:chOff x="620340" y="2014951"/>
              <a:chExt cx="2694234" cy="2019793"/>
            </a:xfrm>
          </p:grpSpPr>
          <p:pic>
            <p:nvPicPr>
              <p:cNvPr id="3" name="Picture 2" descr="A card with a black circle and red square&#10;&#10;AI-generated content may be incorrect.">
                <a:extLst>
                  <a:ext uri="{FF2B5EF4-FFF2-40B4-BE49-F238E27FC236}">
                    <a16:creationId xmlns:a16="http://schemas.microsoft.com/office/drawing/2014/main" id="{7A7DC2EA-7385-46A6-B5DF-2F4FE7C42E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20340" y="2261051"/>
                <a:ext cx="403488" cy="1570694"/>
              </a:xfrm>
              <a:prstGeom prst="rect">
                <a:avLst/>
              </a:prstGeom>
            </p:spPr>
          </p:pic>
          <p:pic>
            <p:nvPicPr>
              <p:cNvPr id="13" name="Picture 12" descr="A chart of a number of red and green dots&#10;&#10;AI-generated content may be incorrect.">
                <a:extLst>
                  <a:ext uri="{FF2B5EF4-FFF2-40B4-BE49-F238E27FC236}">
                    <a16:creationId xmlns:a16="http://schemas.microsoft.com/office/drawing/2014/main" id="{7BA71D7B-748B-3434-7DFF-E7C0836587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73566" y="2014951"/>
                <a:ext cx="2241008" cy="2019793"/>
              </a:xfrm>
              <a:prstGeom prst="rect">
                <a:avLst/>
              </a:prstGeom>
            </p:spPr>
          </p:pic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5964C7AB-D0E0-722F-CA2C-ADA5673C94CA}"/>
              </a:ext>
            </a:extLst>
          </p:cNvPr>
          <p:cNvSpPr txBox="1"/>
          <p:nvPr/>
        </p:nvSpPr>
        <p:spPr>
          <a:xfrm>
            <a:off x="167666" y="4642101"/>
            <a:ext cx="6393292" cy="22741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Transcriptional changes with age in osteocyt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-C) Osteocytes were obtained from endosteal and periosteal cells isolated from young (6 months) or old (24 months) wild-type female and male mice and combined for analysis. (A) Total number of osteocytes obtained from endosteal and periosteal isolations in young or old wild-type females and males. (B) All differentially expressed genes significantly up-(red) or down-(green) regulated with age in osteocytes. (C) Gene ontology terms increasing (red) and decreasing (green) in response to aging in osteocytes. Larger circle sizes and darker colors indicate higher significance.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95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60</TotalTime>
  <Words>148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77</cp:revision>
  <cp:lastPrinted>2024-12-12T18:09:24Z</cp:lastPrinted>
  <dcterms:created xsi:type="dcterms:W3CDTF">2024-09-05T13:29:40Z</dcterms:created>
  <dcterms:modified xsi:type="dcterms:W3CDTF">2025-07-03T14:5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